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7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EEC44-CDFB-4B4E-9F50-99DA06B6D71A}" type="datetimeFigureOut">
              <a:rPr lang="en-GB" smtClean="0"/>
              <a:t>17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5FE1A-F7E7-4BDE-9D6D-F58FB48FD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10447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EEC44-CDFB-4B4E-9F50-99DA06B6D71A}" type="datetimeFigureOut">
              <a:rPr lang="en-GB" smtClean="0"/>
              <a:t>17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5FE1A-F7E7-4BDE-9D6D-F58FB48FD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50453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EEC44-CDFB-4B4E-9F50-99DA06B6D71A}" type="datetimeFigureOut">
              <a:rPr lang="en-GB" smtClean="0"/>
              <a:t>17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5FE1A-F7E7-4BDE-9D6D-F58FB48FD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8372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EEC44-CDFB-4B4E-9F50-99DA06B6D71A}" type="datetimeFigureOut">
              <a:rPr lang="en-GB" smtClean="0"/>
              <a:t>17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5FE1A-F7E7-4BDE-9D6D-F58FB48FD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13432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EEC44-CDFB-4B4E-9F50-99DA06B6D71A}" type="datetimeFigureOut">
              <a:rPr lang="en-GB" smtClean="0"/>
              <a:t>17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5FE1A-F7E7-4BDE-9D6D-F58FB48FD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52907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EEC44-CDFB-4B4E-9F50-99DA06B6D71A}" type="datetimeFigureOut">
              <a:rPr lang="en-GB" smtClean="0"/>
              <a:t>17/07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5FE1A-F7E7-4BDE-9D6D-F58FB48FD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0448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EEC44-CDFB-4B4E-9F50-99DA06B6D71A}" type="datetimeFigureOut">
              <a:rPr lang="en-GB" smtClean="0"/>
              <a:t>17/07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5FE1A-F7E7-4BDE-9D6D-F58FB48FD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26538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EEC44-CDFB-4B4E-9F50-99DA06B6D71A}" type="datetimeFigureOut">
              <a:rPr lang="en-GB" smtClean="0"/>
              <a:t>17/07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5FE1A-F7E7-4BDE-9D6D-F58FB48FD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94879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EEC44-CDFB-4B4E-9F50-99DA06B6D71A}" type="datetimeFigureOut">
              <a:rPr lang="en-GB" smtClean="0"/>
              <a:t>17/07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5FE1A-F7E7-4BDE-9D6D-F58FB48FD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5169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EEC44-CDFB-4B4E-9F50-99DA06B6D71A}" type="datetimeFigureOut">
              <a:rPr lang="en-GB" smtClean="0"/>
              <a:t>17/07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5FE1A-F7E7-4BDE-9D6D-F58FB48FD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33365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EEC44-CDFB-4B4E-9F50-99DA06B6D71A}" type="datetimeFigureOut">
              <a:rPr lang="en-GB" smtClean="0"/>
              <a:t>17/07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5FE1A-F7E7-4BDE-9D6D-F58FB48FD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2452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8EEC44-CDFB-4B4E-9F50-99DA06B6D71A}" type="datetimeFigureOut">
              <a:rPr lang="en-GB" smtClean="0"/>
              <a:t>17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35FE1A-F7E7-4BDE-9D6D-F58FB48FD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2025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5519279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0" y="6217779"/>
            <a:ext cx="12192000" cy="5170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200" b="1" smtClean="0">
                <a:solidFill>
                  <a:srgbClr val="00000A"/>
                </a:solidFill>
                <a:latin typeface="Times New Roman" panose="02020603050405020304" pitchFamily="18" charset="0"/>
                <a:ea typeface="Droid Sans Fallback"/>
              </a:rPr>
              <a:t>Supplementary Figure 2</a:t>
            </a:r>
            <a:r>
              <a:rPr lang="en-US" sz="1200" smtClean="0">
                <a:solidFill>
                  <a:srgbClr val="00000A"/>
                </a:solidFill>
                <a:latin typeface="Times New Roman" panose="02020603050405020304" pitchFamily="18" charset="0"/>
                <a:ea typeface="Droid Sans Fallback"/>
              </a:rPr>
              <a:t>: </a:t>
            </a:r>
            <a:r>
              <a:rPr lang="en-US" sz="1200" dirty="0">
                <a:solidFill>
                  <a:srgbClr val="00000A"/>
                </a:solidFill>
                <a:latin typeface="Times New Roman" panose="02020603050405020304" pitchFamily="18" charset="0"/>
                <a:ea typeface="Droid Sans Fallback"/>
              </a:rPr>
              <a:t>Venn diagram showing the distribution of functions in the four </a:t>
            </a:r>
            <a:r>
              <a:rPr lang="en-US" sz="1200" dirty="0" smtClean="0">
                <a:solidFill>
                  <a:srgbClr val="00000A"/>
                </a:solidFill>
                <a:latin typeface="Times New Roman" panose="02020603050405020304" pitchFamily="18" charset="0"/>
                <a:ea typeface="Droid Sans Fallback"/>
              </a:rPr>
              <a:t>metagenomes. Each </a:t>
            </a:r>
            <a:r>
              <a:rPr lang="en-US" sz="1200" dirty="0">
                <a:solidFill>
                  <a:srgbClr val="00000A"/>
                </a:solidFill>
                <a:latin typeface="Times New Roman" panose="02020603050405020304" pitchFamily="18" charset="0"/>
                <a:ea typeface="Droid Sans Fallback"/>
              </a:rPr>
              <a:t>ellipse corresponds to the metagenome of a site, the overlapping areas represents the functions that are either shared among-  or unique to- each site. Unique functions are explicitly annotated. </a:t>
            </a:r>
            <a:endParaRPr lang="en-GB" sz="1200" dirty="0">
              <a:solidFill>
                <a:srgbClr val="00000A"/>
              </a:solidFill>
              <a:latin typeface="Calibri" panose="020F0502020204030204" pitchFamily="34" charset="0"/>
              <a:ea typeface="Droid Sans Fallback"/>
            </a:endParaRPr>
          </a:p>
        </p:txBody>
      </p:sp>
    </p:spTree>
    <p:extLst>
      <p:ext uri="{BB962C8B-B14F-4D97-AF65-F5344CB8AC3E}">
        <p14:creationId xmlns:p14="http://schemas.microsoft.com/office/powerpoint/2010/main" val="257203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Droid Sans Fallback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sposito, Alfonso</dc:creator>
  <cp:lastModifiedBy>Esposito, Alfonso</cp:lastModifiedBy>
  <cp:revision>3</cp:revision>
  <dcterms:created xsi:type="dcterms:W3CDTF">2018-06-20T12:17:21Z</dcterms:created>
  <dcterms:modified xsi:type="dcterms:W3CDTF">2018-07-17T15:15:37Z</dcterms:modified>
</cp:coreProperties>
</file>